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938963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44" autoAdjust="0"/>
    <p:restoredTop sz="94660"/>
  </p:normalViewPr>
  <p:slideViewPr>
    <p:cSldViewPr>
      <p:cViewPr varScale="1">
        <p:scale>
          <a:sx n="76" d="100"/>
          <a:sy n="76" d="100"/>
        </p:scale>
        <p:origin x="-117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itlin.johnson\Desktop\Measles%20Exposure%20Index%20Paper\Caitlin%20Work\Copy%20of%20ONcase_travel_index_graphs_2011_updated_cj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Futura Std Book" pitchFamily="34" charset="0"/>
              </a:rPr>
              <a:t>Supplemental</a:t>
            </a:r>
            <a:r>
              <a:rPr lang="en-US" b="0" baseline="0" dirty="0">
                <a:latin typeface="Futura Std Book" pitchFamily="34" charset="0"/>
              </a:rPr>
              <a:t> Material:  Figure </a:t>
            </a:r>
            <a:r>
              <a:rPr lang="en-US" b="0" baseline="0" dirty="0" smtClean="0">
                <a:latin typeface="Futura Std Book" pitchFamily="34" charset="0"/>
              </a:rPr>
              <a:t>4B</a:t>
            </a:r>
            <a:endParaRPr lang="en-US" b="0" baseline="0" dirty="0">
              <a:latin typeface="Futura Std Book" pitchFamily="34" charset="0"/>
            </a:endParaRP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Futura Std Book" pitchFamily="34" charset="0"/>
              </a:rPr>
              <a:t>Ontario</a:t>
            </a:r>
            <a:r>
              <a:rPr lang="en-US" b="0" baseline="0" dirty="0">
                <a:latin typeface="Futura Std Book" pitchFamily="34" charset="0"/>
              </a:rPr>
              <a:t> Measles Cases </a:t>
            </a:r>
            <a:r>
              <a:rPr lang="en-US" b="0" baseline="0" dirty="0" smtClean="0">
                <a:latin typeface="Futura Std Book" pitchFamily="34" charset="0"/>
              </a:rPr>
              <a:t>(Importations and </a:t>
            </a:r>
            <a:r>
              <a:rPr lang="en-US" b="0" baseline="0" smtClean="0">
                <a:latin typeface="Futura Std Book" pitchFamily="34" charset="0"/>
              </a:rPr>
              <a:t>Unknown Source) 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0" baseline="0" smtClean="0">
                <a:latin typeface="Futura Std Book" pitchFamily="34" charset="0"/>
              </a:rPr>
              <a:t>and </a:t>
            </a:r>
            <a:r>
              <a:rPr lang="en-US" b="0" baseline="0" dirty="0">
                <a:latin typeface="Futura Std Book" pitchFamily="34" charset="0"/>
              </a:rPr>
              <a:t>Inbound Passenger Volume</a:t>
            </a:r>
          </a:p>
        </c:rich>
      </c:tx>
      <c:layout/>
      <c:overlay val="0"/>
    </c:title>
    <c:autoTitleDeleted val="0"/>
    <c:plotArea>
      <c:layout/>
      <c:barChart>
        <c:barDir val="col"/>
        <c:grouping val="stacked"/>
        <c:varyColors val="0"/>
        <c:ser>
          <c:idx val="4"/>
          <c:order val="1"/>
          <c:tx>
            <c:v>Imported Cases</c:v>
          </c:tx>
          <c:spPr>
            <a:solidFill>
              <a:schemeClr val="accent2"/>
            </a:solidFill>
          </c:spPr>
          <c:invertIfNegative val="0"/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6:$BI$6</c:f>
              <c:numCache>
                <c:formatCode>General</c:formatCode>
                <c:ptCount val="6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1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1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1</c:v>
                </c:pt>
                <c:pt idx="46">
                  <c:v>1</c:v>
                </c:pt>
                <c:pt idx="47">
                  <c:v>0</c:v>
                </c:pt>
                <c:pt idx="48">
                  <c:v>0</c:v>
                </c:pt>
                <c:pt idx="49">
                  <c:v>1</c:v>
                </c:pt>
                <c:pt idx="50">
                  <c:v>1</c:v>
                </c:pt>
                <c:pt idx="51">
                  <c:v>0</c:v>
                </c:pt>
                <c:pt idx="52">
                  <c:v>2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</c:numCache>
            </c:numRef>
          </c:val>
        </c:ser>
        <c:ser>
          <c:idx val="6"/>
          <c:order val="2"/>
          <c:tx>
            <c:v>Unknown Source</c:v>
          </c:tx>
          <c:spPr>
            <a:solidFill>
              <a:schemeClr val="accent3"/>
            </a:solidFill>
          </c:spPr>
          <c:invertIfNegative val="0"/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7:$BI$7</c:f>
              <c:numCache>
                <c:formatCode>General</c:formatCode>
                <c:ptCount val="6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8</c:v>
                </c:pt>
                <c:pt idx="15">
                  <c:v>28</c:v>
                </c:pt>
                <c:pt idx="16">
                  <c:v>18</c:v>
                </c:pt>
                <c:pt idx="17">
                  <c:v>0</c:v>
                </c:pt>
                <c:pt idx="18">
                  <c:v>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5696512"/>
        <c:axId val="85698048"/>
      </c:barChart>
      <c:lineChart>
        <c:grouping val="standard"/>
        <c:varyColors val="0"/>
        <c:ser>
          <c:idx val="2"/>
          <c:order val="0"/>
          <c:tx>
            <c:v>Passenger Volume</c:v>
          </c:tx>
          <c:spPr>
            <a:ln>
              <a:solidFill>
                <a:schemeClr val="accent1"/>
              </a:solidFill>
            </a:ln>
          </c:spPr>
          <c:marker>
            <c:symbol val="none"/>
          </c:marker>
          <c:cat>
            <c:strRef>
              <c:f>cases_travel!$B$1:$BI$1</c:f>
              <c:strCache>
                <c:ptCount val="60"/>
                <c:pt idx="0">
                  <c:v>Jan</c:v>
                </c:pt>
                <c:pt idx="1">
                  <c:v>Feb</c:v>
                </c:pt>
                <c:pt idx="2">
                  <c:v>Mar</c:v>
                </c:pt>
                <c:pt idx="3">
                  <c:v>Apr</c:v>
                </c:pt>
                <c:pt idx="4">
                  <c:v>May</c:v>
                </c:pt>
                <c:pt idx="5">
                  <c:v>Jun</c:v>
                </c:pt>
                <c:pt idx="6">
                  <c:v>Jul</c:v>
                </c:pt>
                <c:pt idx="7">
                  <c:v>Aug</c:v>
                </c:pt>
                <c:pt idx="8">
                  <c:v>Sep</c:v>
                </c:pt>
                <c:pt idx="9">
                  <c:v>Oct</c:v>
                </c:pt>
                <c:pt idx="10">
                  <c:v>Nov</c:v>
                </c:pt>
                <c:pt idx="11">
                  <c:v>Dec</c:v>
                </c:pt>
                <c:pt idx="12">
                  <c:v>Jan</c:v>
                </c:pt>
                <c:pt idx="13">
                  <c:v>Feb</c:v>
                </c:pt>
                <c:pt idx="14">
                  <c:v>Mar</c:v>
                </c:pt>
                <c:pt idx="15">
                  <c:v>Apr</c:v>
                </c:pt>
                <c:pt idx="16">
                  <c:v>May</c:v>
                </c:pt>
                <c:pt idx="17">
                  <c:v>Jun</c:v>
                </c:pt>
                <c:pt idx="18">
                  <c:v>Jul</c:v>
                </c:pt>
                <c:pt idx="19">
                  <c:v>Aug</c:v>
                </c:pt>
                <c:pt idx="20">
                  <c:v>Sep</c:v>
                </c:pt>
                <c:pt idx="21">
                  <c:v>Oct</c:v>
                </c:pt>
                <c:pt idx="22">
                  <c:v>Nov</c:v>
                </c:pt>
                <c:pt idx="23">
                  <c:v>Dec</c:v>
                </c:pt>
                <c:pt idx="24">
                  <c:v>Jan</c:v>
                </c:pt>
                <c:pt idx="25">
                  <c:v>Feb</c:v>
                </c:pt>
                <c:pt idx="26">
                  <c:v>Mar</c:v>
                </c:pt>
                <c:pt idx="27">
                  <c:v>Apr</c:v>
                </c:pt>
                <c:pt idx="28">
                  <c:v>May</c:v>
                </c:pt>
                <c:pt idx="29">
                  <c:v>Jun</c:v>
                </c:pt>
                <c:pt idx="30">
                  <c:v>Jul</c:v>
                </c:pt>
                <c:pt idx="31">
                  <c:v>Aug</c:v>
                </c:pt>
                <c:pt idx="32">
                  <c:v>Sep</c:v>
                </c:pt>
                <c:pt idx="33">
                  <c:v>Oct</c:v>
                </c:pt>
                <c:pt idx="34">
                  <c:v>Nov</c:v>
                </c:pt>
                <c:pt idx="35">
                  <c:v>Dec</c:v>
                </c:pt>
                <c:pt idx="36">
                  <c:v>Jan</c:v>
                </c:pt>
                <c:pt idx="37">
                  <c:v>Feb</c:v>
                </c:pt>
                <c:pt idx="38">
                  <c:v>Mar</c:v>
                </c:pt>
                <c:pt idx="39">
                  <c:v>Apr</c:v>
                </c:pt>
                <c:pt idx="40">
                  <c:v>May</c:v>
                </c:pt>
                <c:pt idx="41">
                  <c:v>Jun</c:v>
                </c:pt>
                <c:pt idx="42">
                  <c:v>Jul</c:v>
                </c:pt>
                <c:pt idx="43">
                  <c:v>Aug</c:v>
                </c:pt>
                <c:pt idx="44">
                  <c:v>Sep</c:v>
                </c:pt>
                <c:pt idx="45">
                  <c:v>Oct</c:v>
                </c:pt>
                <c:pt idx="46">
                  <c:v>Nov</c:v>
                </c:pt>
                <c:pt idx="47">
                  <c:v>Dec</c:v>
                </c:pt>
                <c:pt idx="48">
                  <c:v>Jan</c:v>
                </c:pt>
                <c:pt idx="49">
                  <c:v>Feb</c:v>
                </c:pt>
                <c:pt idx="50">
                  <c:v>Mar</c:v>
                </c:pt>
                <c:pt idx="51">
                  <c:v>Apr</c:v>
                </c:pt>
                <c:pt idx="52">
                  <c:v>May</c:v>
                </c:pt>
                <c:pt idx="53">
                  <c:v>Jun</c:v>
                </c:pt>
                <c:pt idx="54">
                  <c:v>Jul</c:v>
                </c:pt>
                <c:pt idx="55">
                  <c:v>Aug</c:v>
                </c:pt>
                <c:pt idx="56">
                  <c:v>Sep</c:v>
                </c:pt>
                <c:pt idx="57">
                  <c:v>Oct</c:v>
                </c:pt>
                <c:pt idx="58">
                  <c:v>Nov</c:v>
                </c:pt>
                <c:pt idx="59">
                  <c:v>Dec</c:v>
                </c:pt>
              </c:strCache>
            </c:strRef>
          </c:cat>
          <c:val>
            <c:numRef>
              <c:f>cases_travel!$B$4:$BI$4</c:f>
              <c:numCache>
                <c:formatCode>General</c:formatCode>
                <c:ptCount val="60"/>
                <c:pt idx="0">
                  <c:v>586667</c:v>
                </c:pt>
                <c:pt idx="1">
                  <c:v>571935</c:v>
                </c:pt>
                <c:pt idx="2">
                  <c:v>709913</c:v>
                </c:pt>
                <c:pt idx="3">
                  <c:v>631506</c:v>
                </c:pt>
                <c:pt idx="4">
                  <c:v>637228</c:v>
                </c:pt>
                <c:pt idx="5">
                  <c:v>656351</c:v>
                </c:pt>
                <c:pt idx="6">
                  <c:v>683357</c:v>
                </c:pt>
                <c:pt idx="7">
                  <c:v>741691</c:v>
                </c:pt>
                <c:pt idx="8">
                  <c:v>679974</c:v>
                </c:pt>
                <c:pt idx="9">
                  <c:v>607377</c:v>
                </c:pt>
                <c:pt idx="10">
                  <c:v>522246</c:v>
                </c:pt>
                <c:pt idx="11">
                  <c:v>546920</c:v>
                </c:pt>
                <c:pt idx="12">
                  <c:v>590492</c:v>
                </c:pt>
                <c:pt idx="13">
                  <c:v>560186</c:v>
                </c:pt>
                <c:pt idx="14">
                  <c:v>697307</c:v>
                </c:pt>
                <c:pt idx="15">
                  <c:v>626023</c:v>
                </c:pt>
                <c:pt idx="16">
                  <c:v>669826</c:v>
                </c:pt>
                <c:pt idx="17">
                  <c:v>719667</c:v>
                </c:pt>
                <c:pt idx="18">
                  <c:v>707277</c:v>
                </c:pt>
                <c:pt idx="19">
                  <c:v>729080</c:v>
                </c:pt>
                <c:pt idx="20">
                  <c:v>630366</c:v>
                </c:pt>
                <c:pt idx="21">
                  <c:v>581281</c:v>
                </c:pt>
                <c:pt idx="22">
                  <c:v>521748</c:v>
                </c:pt>
                <c:pt idx="23">
                  <c:v>549978</c:v>
                </c:pt>
                <c:pt idx="24">
                  <c:v>586395</c:v>
                </c:pt>
                <c:pt idx="25">
                  <c:v>536396</c:v>
                </c:pt>
                <c:pt idx="26">
                  <c:v>670330</c:v>
                </c:pt>
                <c:pt idx="27">
                  <c:v>610440</c:v>
                </c:pt>
                <c:pt idx="28">
                  <c:v>605852</c:v>
                </c:pt>
                <c:pt idx="29">
                  <c:v>627974</c:v>
                </c:pt>
                <c:pt idx="30">
                  <c:v>720237</c:v>
                </c:pt>
                <c:pt idx="31">
                  <c:v>764077</c:v>
                </c:pt>
                <c:pt idx="32">
                  <c:v>648943</c:v>
                </c:pt>
                <c:pt idx="33">
                  <c:v>608052</c:v>
                </c:pt>
                <c:pt idx="34">
                  <c:v>526355</c:v>
                </c:pt>
                <c:pt idx="35">
                  <c:v>579162</c:v>
                </c:pt>
                <c:pt idx="36">
                  <c:v>588991</c:v>
                </c:pt>
                <c:pt idx="37">
                  <c:v>531158</c:v>
                </c:pt>
                <c:pt idx="38">
                  <c:v>688806</c:v>
                </c:pt>
                <c:pt idx="39">
                  <c:v>621870</c:v>
                </c:pt>
                <c:pt idx="40">
                  <c:v>686496</c:v>
                </c:pt>
                <c:pt idx="41">
                  <c:v>695833</c:v>
                </c:pt>
                <c:pt idx="42">
                  <c:v>785146</c:v>
                </c:pt>
                <c:pt idx="43">
                  <c:v>819891</c:v>
                </c:pt>
                <c:pt idx="44">
                  <c:v>720533</c:v>
                </c:pt>
                <c:pt idx="45">
                  <c:v>681924</c:v>
                </c:pt>
                <c:pt idx="46">
                  <c:v>584840</c:v>
                </c:pt>
                <c:pt idx="47">
                  <c:v>637906</c:v>
                </c:pt>
                <c:pt idx="48">
                  <c:v>636402</c:v>
                </c:pt>
                <c:pt idx="49">
                  <c:v>565856</c:v>
                </c:pt>
                <c:pt idx="50">
                  <c:v>738715</c:v>
                </c:pt>
                <c:pt idx="51">
                  <c:v>671225</c:v>
                </c:pt>
                <c:pt idx="52">
                  <c:v>717182</c:v>
                </c:pt>
                <c:pt idx="53">
                  <c:v>716305</c:v>
                </c:pt>
                <c:pt idx="54">
                  <c:v>817078</c:v>
                </c:pt>
                <c:pt idx="55">
                  <c:v>848592</c:v>
                </c:pt>
                <c:pt idx="56">
                  <c:v>748225</c:v>
                </c:pt>
                <c:pt idx="57">
                  <c:v>664161</c:v>
                </c:pt>
                <c:pt idx="58">
                  <c:v>590767</c:v>
                </c:pt>
                <c:pt idx="59">
                  <c:v>63197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5708160"/>
        <c:axId val="85706240"/>
      </c:lineChart>
      <c:catAx>
        <c:axId val="856965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anchor="t" anchorCtr="0"/>
          <a:lstStyle/>
          <a:p>
            <a:pPr>
              <a:defRPr sz="800">
                <a:latin typeface="Futura Std Book" pitchFamily="34" charset="0"/>
              </a:defRPr>
            </a:pPr>
            <a:endParaRPr lang="en-US"/>
          </a:p>
        </c:txPr>
        <c:crossAx val="85698048"/>
        <c:crosses val="autoZero"/>
        <c:auto val="1"/>
        <c:lblAlgn val="ctr"/>
        <c:lblOffset val="50"/>
        <c:tickLblSkip val="2"/>
        <c:noMultiLvlLbl val="0"/>
      </c:catAx>
      <c:valAx>
        <c:axId val="85698048"/>
        <c:scaling>
          <c:orientation val="minMax"/>
          <c:max val="30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0" baseline="0">
                    <a:latin typeface="Futura Std Book" pitchFamily="34" charset="0"/>
                  </a:rPr>
                  <a:t>Measles Cases</a:t>
                </a:r>
                <a:endParaRPr lang="en-US" sz="1200" b="0">
                  <a:latin typeface="Futura Std Book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Futura Std Book" pitchFamily="34" charset="0"/>
              </a:defRPr>
            </a:pPr>
            <a:endParaRPr lang="en-US"/>
          </a:p>
        </c:txPr>
        <c:crossAx val="85696512"/>
        <c:crosses val="autoZero"/>
        <c:crossBetween val="between"/>
      </c:valAx>
      <c:valAx>
        <c:axId val="85706240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0">
                    <a:latin typeface="Futura Std Book" pitchFamily="34" charset="0"/>
                  </a:rPr>
                  <a:t>Passenger Volume</a:t>
                </a:r>
                <a:endParaRPr lang="en-US"/>
              </a:p>
            </c:rich>
          </c:tx>
          <c:layout/>
          <c:overlay val="0"/>
        </c:title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Futura Std Book" pitchFamily="34" charset="0"/>
              </a:defRPr>
            </a:pPr>
            <a:endParaRPr lang="en-US"/>
          </a:p>
        </c:txPr>
        <c:crossAx val="85708160"/>
        <c:crosses val="max"/>
        <c:crossBetween val="between"/>
      </c:valAx>
      <c:catAx>
        <c:axId val="85708160"/>
        <c:scaling>
          <c:orientation val="minMax"/>
        </c:scaling>
        <c:delete val="1"/>
        <c:axPos val="b"/>
        <c:majorTickMark val="out"/>
        <c:minorTickMark val="none"/>
        <c:tickLblPos val="nextTo"/>
        <c:crossAx val="85706240"/>
        <c:crosses val="autoZero"/>
        <c:auto val="1"/>
        <c:lblAlgn val="ctr"/>
        <c:lblOffset val="100"/>
        <c:noMultiLvlLbl val="0"/>
      </c:catAx>
    </c:plotArea>
    <c:legend>
      <c:legendPos val="b"/>
      <c:layout/>
      <c:overlay val="0"/>
      <c:txPr>
        <a:bodyPr/>
        <a:lstStyle/>
        <a:p>
          <a:pPr>
            <a:defRPr>
              <a:latin typeface="Futura Std Book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69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103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735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3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289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70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63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75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8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5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42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7B648-508E-4857-AB38-918A8D6D9E13}" type="datetimeFigureOut">
              <a:rPr lang="en-US" smtClean="0"/>
              <a:t>3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F668A-07C7-498E-BE48-7FC6565E94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158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6127522"/>
            <a:ext cx="6934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Futura Std Book" pitchFamily="34" charset="0"/>
              </a:rPr>
              <a:t>               2007                                   2008                                    2009                                    2010                                   2011 </a:t>
            </a:r>
            <a:endParaRPr lang="en-US" sz="800" dirty="0">
              <a:latin typeface="Futura Std Book" pitchFamily="34" charset="0"/>
            </a:endParaRPr>
          </a:p>
        </p:txBody>
      </p:sp>
      <p:graphicFrame>
        <p:nvGraphicFramePr>
          <p:cNvPr id="6" name="Chart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1582770"/>
              </p:ext>
            </p:extLst>
          </p:nvPr>
        </p:nvGraphicFramePr>
        <p:xfrm>
          <a:off x="236904" y="284529"/>
          <a:ext cx="8670192" cy="62889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50110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2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yers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tsadmin</dc:creator>
  <cp:lastModifiedBy>Sarah Wilson</cp:lastModifiedBy>
  <cp:revision>26</cp:revision>
  <cp:lastPrinted>2013-06-10T14:22:52Z</cp:lastPrinted>
  <dcterms:created xsi:type="dcterms:W3CDTF">2013-06-05T19:21:59Z</dcterms:created>
  <dcterms:modified xsi:type="dcterms:W3CDTF">2015-04-01T00:36:37Z</dcterms:modified>
</cp:coreProperties>
</file>